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285" r:id="rId2"/>
    <p:sldId id="299" r:id="rId3"/>
    <p:sldId id="262" r:id="rId4"/>
    <p:sldId id="268" r:id="rId5"/>
    <p:sldId id="279" r:id="rId6"/>
    <p:sldId id="298" r:id="rId7"/>
  </p:sldIdLst>
  <p:sldSz cx="12192000" cy="8686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FA4E7"/>
    <a:srgbClr val="61EBBB"/>
    <a:srgbClr val="F1B7DC"/>
    <a:srgbClr val="F2AFCD"/>
    <a:srgbClr val="D294EF"/>
    <a:srgbClr val="BFC5ED"/>
    <a:srgbClr val="B0ADEE"/>
    <a:srgbClr val="A690EF"/>
    <a:srgbClr val="EDD096"/>
    <a:srgbClr val="FF6CA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1348"/>
    <p:restoredTop sz="96093"/>
  </p:normalViewPr>
  <p:slideViewPr>
    <p:cSldViewPr snapToGrid="0">
      <p:cViewPr varScale="1">
        <p:scale>
          <a:sx n="86" d="100"/>
          <a:sy n="86" d="100"/>
        </p:scale>
        <p:origin x="248" y="336"/>
      </p:cViewPr>
      <p:guideLst/>
    </p:cSldViewPr>
  </p:slideViewPr>
  <p:notesTextViewPr>
    <p:cViewPr>
      <p:scale>
        <a:sx n="114" d="100"/>
        <a:sy n="114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26DA29-F2F8-7D47-9309-4E336417E852}" type="datetimeFigureOut">
              <a:rPr lang="en-US" smtClean="0"/>
              <a:t>12/30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63650" y="1143000"/>
            <a:ext cx="4330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2F6625-BC70-4141-99B4-22EF7D8B2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3897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21660"/>
            <a:ext cx="10363200" cy="3024293"/>
          </a:xfrm>
        </p:spPr>
        <p:txBody>
          <a:bodyPr anchor="b"/>
          <a:lstStyle>
            <a:lvl1pPr algn="ctr">
              <a:defRPr sz="7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562581"/>
            <a:ext cx="9144000" cy="2097299"/>
          </a:xfrm>
        </p:spPr>
        <p:txBody>
          <a:bodyPr/>
          <a:lstStyle>
            <a:lvl1pPr marL="0" indent="0" algn="ctr">
              <a:buNone/>
              <a:defRPr sz="3040"/>
            </a:lvl1pPr>
            <a:lvl2pPr marL="579135" indent="0" algn="ctr">
              <a:buNone/>
              <a:defRPr sz="2533"/>
            </a:lvl2pPr>
            <a:lvl3pPr marL="1158270" indent="0" algn="ctr">
              <a:buNone/>
              <a:defRPr sz="2280"/>
            </a:lvl3pPr>
            <a:lvl4pPr marL="1737406" indent="0" algn="ctr">
              <a:buNone/>
              <a:defRPr sz="2027"/>
            </a:lvl4pPr>
            <a:lvl5pPr marL="2316541" indent="0" algn="ctr">
              <a:buNone/>
              <a:defRPr sz="2027"/>
            </a:lvl5pPr>
            <a:lvl6pPr marL="2895676" indent="0" algn="ctr">
              <a:buNone/>
              <a:defRPr sz="2027"/>
            </a:lvl6pPr>
            <a:lvl7pPr marL="3474811" indent="0" algn="ctr">
              <a:buNone/>
              <a:defRPr sz="2027"/>
            </a:lvl7pPr>
            <a:lvl8pPr marL="4053947" indent="0" algn="ctr">
              <a:buNone/>
              <a:defRPr sz="2027"/>
            </a:lvl8pPr>
            <a:lvl9pPr marL="4633082" indent="0" algn="ctr">
              <a:buNone/>
              <a:defRPr sz="202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82E42-B3E8-8344-A154-069FA40D322B}" type="datetimeFigureOut">
              <a:rPr lang="en-US" smtClean="0"/>
              <a:t>12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2F32E-8D3B-114D-834D-36E1EEE5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920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82E42-B3E8-8344-A154-069FA40D322B}" type="datetimeFigureOut">
              <a:rPr lang="en-US" smtClean="0"/>
              <a:t>12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2F32E-8D3B-114D-834D-36E1EEE5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240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62492"/>
            <a:ext cx="2628900" cy="736166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62492"/>
            <a:ext cx="7734300" cy="736166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82E42-B3E8-8344-A154-069FA40D322B}" type="datetimeFigureOut">
              <a:rPr lang="en-US" smtClean="0"/>
              <a:t>12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2F32E-8D3B-114D-834D-36E1EEE5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1274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82E42-B3E8-8344-A154-069FA40D322B}" type="datetimeFigureOut">
              <a:rPr lang="en-US" smtClean="0"/>
              <a:t>12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2F32E-8D3B-114D-834D-36E1EEE5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961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165670"/>
            <a:ext cx="10515600" cy="3613467"/>
          </a:xfrm>
        </p:spPr>
        <p:txBody>
          <a:bodyPr anchor="b"/>
          <a:lstStyle>
            <a:lvl1pPr>
              <a:defRPr sz="7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813322"/>
            <a:ext cx="10515600" cy="1900237"/>
          </a:xfrm>
        </p:spPr>
        <p:txBody>
          <a:bodyPr/>
          <a:lstStyle>
            <a:lvl1pPr marL="0" indent="0">
              <a:buNone/>
              <a:defRPr sz="3040">
                <a:solidFill>
                  <a:schemeClr val="tx1">
                    <a:tint val="82000"/>
                  </a:schemeClr>
                </a:solidFill>
              </a:defRPr>
            </a:lvl1pPr>
            <a:lvl2pPr marL="579135" indent="0">
              <a:buNone/>
              <a:defRPr sz="2533">
                <a:solidFill>
                  <a:schemeClr val="tx1">
                    <a:tint val="82000"/>
                  </a:schemeClr>
                </a:solidFill>
              </a:defRPr>
            </a:lvl2pPr>
            <a:lvl3pPr marL="1158270" indent="0">
              <a:buNone/>
              <a:defRPr sz="2280">
                <a:solidFill>
                  <a:schemeClr val="tx1">
                    <a:tint val="82000"/>
                  </a:schemeClr>
                </a:solidFill>
              </a:defRPr>
            </a:lvl3pPr>
            <a:lvl4pPr marL="1737406" indent="0">
              <a:buNone/>
              <a:defRPr sz="2027">
                <a:solidFill>
                  <a:schemeClr val="tx1">
                    <a:tint val="82000"/>
                  </a:schemeClr>
                </a:solidFill>
              </a:defRPr>
            </a:lvl4pPr>
            <a:lvl5pPr marL="2316541" indent="0">
              <a:buNone/>
              <a:defRPr sz="2027">
                <a:solidFill>
                  <a:schemeClr val="tx1">
                    <a:tint val="82000"/>
                  </a:schemeClr>
                </a:solidFill>
              </a:defRPr>
            </a:lvl5pPr>
            <a:lvl6pPr marL="2895676" indent="0">
              <a:buNone/>
              <a:defRPr sz="2027">
                <a:solidFill>
                  <a:schemeClr val="tx1">
                    <a:tint val="82000"/>
                  </a:schemeClr>
                </a:solidFill>
              </a:defRPr>
            </a:lvl6pPr>
            <a:lvl7pPr marL="3474811" indent="0">
              <a:buNone/>
              <a:defRPr sz="2027">
                <a:solidFill>
                  <a:schemeClr val="tx1">
                    <a:tint val="82000"/>
                  </a:schemeClr>
                </a:solidFill>
              </a:defRPr>
            </a:lvl7pPr>
            <a:lvl8pPr marL="4053947" indent="0">
              <a:buNone/>
              <a:defRPr sz="2027">
                <a:solidFill>
                  <a:schemeClr val="tx1">
                    <a:tint val="82000"/>
                  </a:schemeClr>
                </a:solidFill>
              </a:defRPr>
            </a:lvl8pPr>
            <a:lvl9pPr marL="4633082" indent="0">
              <a:buNone/>
              <a:defRPr sz="2027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82E42-B3E8-8344-A154-069FA40D322B}" type="datetimeFigureOut">
              <a:rPr lang="en-US" smtClean="0"/>
              <a:t>12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2F32E-8D3B-114D-834D-36E1EEE5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155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312458"/>
            <a:ext cx="5181600" cy="55116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312458"/>
            <a:ext cx="5181600" cy="55116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82E42-B3E8-8344-A154-069FA40D322B}" type="datetimeFigureOut">
              <a:rPr lang="en-US" smtClean="0"/>
              <a:t>12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2F32E-8D3B-114D-834D-36E1EEE5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140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62494"/>
            <a:ext cx="10515600" cy="167904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129473"/>
            <a:ext cx="5157787" cy="1043622"/>
          </a:xfrm>
        </p:spPr>
        <p:txBody>
          <a:bodyPr anchor="b"/>
          <a:lstStyle>
            <a:lvl1pPr marL="0" indent="0">
              <a:buNone/>
              <a:defRPr sz="3040" b="1"/>
            </a:lvl1pPr>
            <a:lvl2pPr marL="579135" indent="0">
              <a:buNone/>
              <a:defRPr sz="2533" b="1"/>
            </a:lvl2pPr>
            <a:lvl3pPr marL="1158270" indent="0">
              <a:buNone/>
              <a:defRPr sz="2280" b="1"/>
            </a:lvl3pPr>
            <a:lvl4pPr marL="1737406" indent="0">
              <a:buNone/>
              <a:defRPr sz="2027" b="1"/>
            </a:lvl4pPr>
            <a:lvl5pPr marL="2316541" indent="0">
              <a:buNone/>
              <a:defRPr sz="2027" b="1"/>
            </a:lvl5pPr>
            <a:lvl6pPr marL="2895676" indent="0">
              <a:buNone/>
              <a:defRPr sz="2027" b="1"/>
            </a:lvl6pPr>
            <a:lvl7pPr marL="3474811" indent="0">
              <a:buNone/>
              <a:defRPr sz="2027" b="1"/>
            </a:lvl7pPr>
            <a:lvl8pPr marL="4053947" indent="0">
              <a:buNone/>
              <a:defRPr sz="2027" b="1"/>
            </a:lvl8pPr>
            <a:lvl9pPr marL="4633082" indent="0">
              <a:buNone/>
              <a:defRPr sz="202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173095"/>
            <a:ext cx="5157787" cy="466714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129473"/>
            <a:ext cx="5183188" cy="1043622"/>
          </a:xfrm>
        </p:spPr>
        <p:txBody>
          <a:bodyPr anchor="b"/>
          <a:lstStyle>
            <a:lvl1pPr marL="0" indent="0">
              <a:buNone/>
              <a:defRPr sz="3040" b="1"/>
            </a:lvl1pPr>
            <a:lvl2pPr marL="579135" indent="0">
              <a:buNone/>
              <a:defRPr sz="2533" b="1"/>
            </a:lvl2pPr>
            <a:lvl3pPr marL="1158270" indent="0">
              <a:buNone/>
              <a:defRPr sz="2280" b="1"/>
            </a:lvl3pPr>
            <a:lvl4pPr marL="1737406" indent="0">
              <a:buNone/>
              <a:defRPr sz="2027" b="1"/>
            </a:lvl4pPr>
            <a:lvl5pPr marL="2316541" indent="0">
              <a:buNone/>
              <a:defRPr sz="2027" b="1"/>
            </a:lvl5pPr>
            <a:lvl6pPr marL="2895676" indent="0">
              <a:buNone/>
              <a:defRPr sz="2027" b="1"/>
            </a:lvl6pPr>
            <a:lvl7pPr marL="3474811" indent="0">
              <a:buNone/>
              <a:defRPr sz="2027" b="1"/>
            </a:lvl7pPr>
            <a:lvl8pPr marL="4053947" indent="0">
              <a:buNone/>
              <a:defRPr sz="2027" b="1"/>
            </a:lvl8pPr>
            <a:lvl9pPr marL="4633082" indent="0">
              <a:buNone/>
              <a:defRPr sz="202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173095"/>
            <a:ext cx="5183188" cy="466714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82E42-B3E8-8344-A154-069FA40D322B}" type="datetimeFigureOut">
              <a:rPr lang="en-US" smtClean="0"/>
              <a:t>12/3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2F32E-8D3B-114D-834D-36E1EEE5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121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82E42-B3E8-8344-A154-069FA40D322B}" type="datetimeFigureOut">
              <a:rPr lang="en-US" smtClean="0"/>
              <a:t>12/3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2F32E-8D3B-114D-834D-36E1EEE5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56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82E42-B3E8-8344-A154-069FA40D322B}" type="datetimeFigureOut">
              <a:rPr lang="en-US" smtClean="0"/>
              <a:t>12/3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2F32E-8D3B-114D-834D-36E1EEE5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4478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79120"/>
            <a:ext cx="3932237" cy="2026920"/>
          </a:xfrm>
        </p:spPr>
        <p:txBody>
          <a:bodyPr anchor="b"/>
          <a:lstStyle>
            <a:lvl1pPr>
              <a:defRPr sz="405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50740"/>
            <a:ext cx="6172200" cy="6173258"/>
          </a:xfrm>
        </p:spPr>
        <p:txBody>
          <a:bodyPr/>
          <a:lstStyle>
            <a:lvl1pPr>
              <a:defRPr sz="4053"/>
            </a:lvl1pPr>
            <a:lvl2pPr>
              <a:defRPr sz="3547"/>
            </a:lvl2pPr>
            <a:lvl3pPr>
              <a:defRPr sz="3040"/>
            </a:lvl3pPr>
            <a:lvl4pPr>
              <a:defRPr sz="2533"/>
            </a:lvl4pPr>
            <a:lvl5pPr>
              <a:defRPr sz="2533"/>
            </a:lvl5pPr>
            <a:lvl6pPr>
              <a:defRPr sz="2533"/>
            </a:lvl6pPr>
            <a:lvl7pPr>
              <a:defRPr sz="2533"/>
            </a:lvl7pPr>
            <a:lvl8pPr>
              <a:defRPr sz="2533"/>
            </a:lvl8pPr>
            <a:lvl9pPr>
              <a:defRPr sz="25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06040"/>
            <a:ext cx="3932237" cy="4828011"/>
          </a:xfrm>
        </p:spPr>
        <p:txBody>
          <a:bodyPr/>
          <a:lstStyle>
            <a:lvl1pPr marL="0" indent="0">
              <a:buNone/>
              <a:defRPr sz="2027"/>
            </a:lvl1pPr>
            <a:lvl2pPr marL="579135" indent="0">
              <a:buNone/>
              <a:defRPr sz="1773"/>
            </a:lvl2pPr>
            <a:lvl3pPr marL="1158270" indent="0">
              <a:buNone/>
              <a:defRPr sz="1520"/>
            </a:lvl3pPr>
            <a:lvl4pPr marL="1737406" indent="0">
              <a:buNone/>
              <a:defRPr sz="1267"/>
            </a:lvl4pPr>
            <a:lvl5pPr marL="2316541" indent="0">
              <a:buNone/>
              <a:defRPr sz="1267"/>
            </a:lvl5pPr>
            <a:lvl6pPr marL="2895676" indent="0">
              <a:buNone/>
              <a:defRPr sz="1267"/>
            </a:lvl6pPr>
            <a:lvl7pPr marL="3474811" indent="0">
              <a:buNone/>
              <a:defRPr sz="1267"/>
            </a:lvl7pPr>
            <a:lvl8pPr marL="4053947" indent="0">
              <a:buNone/>
              <a:defRPr sz="1267"/>
            </a:lvl8pPr>
            <a:lvl9pPr marL="4633082" indent="0">
              <a:buNone/>
              <a:defRPr sz="12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82E42-B3E8-8344-A154-069FA40D322B}" type="datetimeFigureOut">
              <a:rPr lang="en-US" smtClean="0"/>
              <a:t>12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2F32E-8D3B-114D-834D-36E1EEE5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9685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79120"/>
            <a:ext cx="3932237" cy="2026920"/>
          </a:xfrm>
        </p:spPr>
        <p:txBody>
          <a:bodyPr anchor="b"/>
          <a:lstStyle>
            <a:lvl1pPr>
              <a:defRPr sz="405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50740"/>
            <a:ext cx="6172200" cy="6173258"/>
          </a:xfrm>
        </p:spPr>
        <p:txBody>
          <a:bodyPr anchor="t"/>
          <a:lstStyle>
            <a:lvl1pPr marL="0" indent="0">
              <a:buNone/>
              <a:defRPr sz="4053"/>
            </a:lvl1pPr>
            <a:lvl2pPr marL="579135" indent="0">
              <a:buNone/>
              <a:defRPr sz="3547"/>
            </a:lvl2pPr>
            <a:lvl3pPr marL="1158270" indent="0">
              <a:buNone/>
              <a:defRPr sz="3040"/>
            </a:lvl3pPr>
            <a:lvl4pPr marL="1737406" indent="0">
              <a:buNone/>
              <a:defRPr sz="2533"/>
            </a:lvl4pPr>
            <a:lvl5pPr marL="2316541" indent="0">
              <a:buNone/>
              <a:defRPr sz="2533"/>
            </a:lvl5pPr>
            <a:lvl6pPr marL="2895676" indent="0">
              <a:buNone/>
              <a:defRPr sz="2533"/>
            </a:lvl6pPr>
            <a:lvl7pPr marL="3474811" indent="0">
              <a:buNone/>
              <a:defRPr sz="2533"/>
            </a:lvl7pPr>
            <a:lvl8pPr marL="4053947" indent="0">
              <a:buNone/>
              <a:defRPr sz="2533"/>
            </a:lvl8pPr>
            <a:lvl9pPr marL="4633082" indent="0">
              <a:buNone/>
              <a:defRPr sz="25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06040"/>
            <a:ext cx="3932237" cy="4828011"/>
          </a:xfrm>
        </p:spPr>
        <p:txBody>
          <a:bodyPr/>
          <a:lstStyle>
            <a:lvl1pPr marL="0" indent="0">
              <a:buNone/>
              <a:defRPr sz="2027"/>
            </a:lvl1pPr>
            <a:lvl2pPr marL="579135" indent="0">
              <a:buNone/>
              <a:defRPr sz="1773"/>
            </a:lvl2pPr>
            <a:lvl3pPr marL="1158270" indent="0">
              <a:buNone/>
              <a:defRPr sz="1520"/>
            </a:lvl3pPr>
            <a:lvl4pPr marL="1737406" indent="0">
              <a:buNone/>
              <a:defRPr sz="1267"/>
            </a:lvl4pPr>
            <a:lvl5pPr marL="2316541" indent="0">
              <a:buNone/>
              <a:defRPr sz="1267"/>
            </a:lvl5pPr>
            <a:lvl6pPr marL="2895676" indent="0">
              <a:buNone/>
              <a:defRPr sz="1267"/>
            </a:lvl6pPr>
            <a:lvl7pPr marL="3474811" indent="0">
              <a:buNone/>
              <a:defRPr sz="1267"/>
            </a:lvl7pPr>
            <a:lvl8pPr marL="4053947" indent="0">
              <a:buNone/>
              <a:defRPr sz="1267"/>
            </a:lvl8pPr>
            <a:lvl9pPr marL="4633082" indent="0">
              <a:buNone/>
              <a:defRPr sz="12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82E42-B3E8-8344-A154-069FA40D322B}" type="datetimeFigureOut">
              <a:rPr lang="en-US" smtClean="0"/>
              <a:t>12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2F32E-8D3B-114D-834D-36E1EEE5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798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62494"/>
            <a:ext cx="10515600" cy="16790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312458"/>
            <a:ext cx="10515600" cy="551169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051378"/>
            <a:ext cx="274320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B82E42-B3E8-8344-A154-069FA40D322B}" type="datetimeFigureOut">
              <a:rPr lang="en-US" smtClean="0"/>
              <a:t>12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051378"/>
            <a:ext cx="411480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051378"/>
            <a:ext cx="274320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972F32E-8D3B-114D-834D-36E1EEE5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709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58270" rtl="0" eaLnBrk="1" latinLnBrk="0" hangingPunct="1">
        <a:lnSpc>
          <a:spcPct val="90000"/>
        </a:lnSpc>
        <a:spcBef>
          <a:spcPct val="0"/>
        </a:spcBef>
        <a:buNone/>
        <a:defRPr sz="55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9568" indent="-289568" algn="l" defTabSz="1158270" rtl="0" eaLnBrk="1" latinLnBrk="0" hangingPunct="1">
        <a:lnSpc>
          <a:spcPct val="90000"/>
        </a:lnSpc>
        <a:spcBef>
          <a:spcPts val="1267"/>
        </a:spcBef>
        <a:buFont typeface="Arial" panose="020B0604020202020204" pitchFamily="34" charset="0"/>
        <a:buChar char="•"/>
        <a:defRPr sz="3547" kern="1200">
          <a:solidFill>
            <a:schemeClr val="tx1"/>
          </a:solidFill>
          <a:latin typeface="+mn-lt"/>
          <a:ea typeface="+mn-ea"/>
          <a:cs typeface="+mn-cs"/>
        </a:defRPr>
      </a:lvl1pPr>
      <a:lvl2pPr marL="868703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3040" kern="1200">
          <a:solidFill>
            <a:schemeClr val="tx1"/>
          </a:solidFill>
          <a:latin typeface="+mn-lt"/>
          <a:ea typeface="+mn-ea"/>
          <a:cs typeface="+mn-cs"/>
        </a:defRPr>
      </a:lvl2pPr>
      <a:lvl3pPr marL="1447838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533" kern="1200">
          <a:solidFill>
            <a:schemeClr val="tx1"/>
          </a:solidFill>
          <a:latin typeface="+mn-lt"/>
          <a:ea typeface="+mn-ea"/>
          <a:cs typeface="+mn-cs"/>
        </a:defRPr>
      </a:lvl3pPr>
      <a:lvl4pPr marL="2026973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4pPr>
      <a:lvl5pPr marL="2606109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5pPr>
      <a:lvl6pPr marL="3185244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6pPr>
      <a:lvl7pPr marL="3764379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7pPr>
      <a:lvl8pPr marL="4343514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8pPr>
      <a:lvl9pPr marL="4922650" indent="-289568" algn="l" defTabSz="115827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1pPr>
      <a:lvl2pPr marL="579135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2pPr>
      <a:lvl3pPr marL="1158270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3pPr>
      <a:lvl4pPr marL="1737406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4pPr>
      <a:lvl5pPr marL="2316541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5pPr>
      <a:lvl6pPr marL="2895676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6pPr>
      <a:lvl7pPr marL="3474811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7pPr>
      <a:lvl8pPr marL="4053947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8pPr>
      <a:lvl9pPr marL="4633082" algn="l" defTabSz="1158270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10" Type="http://schemas.openxmlformats.org/officeDocument/2006/relationships/image" Target="../media/image11.emf"/><Relationship Id="rId4" Type="http://schemas.openxmlformats.org/officeDocument/2006/relationships/image" Target="../media/image5.emf"/><Relationship Id="rId9" Type="http://schemas.openxmlformats.org/officeDocument/2006/relationships/image" Target="../media/image10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884360-3C3F-C847-3784-B89914343F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FIGURES</a:t>
            </a:r>
          </a:p>
        </p:txBody>
      </p:sp>
    </p:spTree>
    <p:extLst>
      <p:ext uri="{BB962C8B-B14F-4D97-AF65-F5344CB8AC3E}">
        <p14:creationId xmlns:p14="http://schemas.microsoft.com/office/powerpoint/2010/main" val="17216830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877FDE7-2C7B-FECE-B721-4C407F7F4B64}"/>
              </a:ext>
            </a:extLst>
          </p:cNvPr>
          <p:cNvSpPr txBox="1"/>
          <p:nvPr/>
        </p:nvSpPr>
        <p:spPr>
          <a:xfrm>
            <a:off x="754814" y="940333"/>
            <a:ext cx="11183815" cy="70891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1440"/>
              </a:spcBef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Data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1440"/>
              </a:spcBef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. S1 An evaluation different numbers of base classifiers on meta-model performance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X axis shows which model or classifier is being shown while the Y axis shows the score and respective metric being evaluated.</a:t>
            </a:r>
          </a:p>
          <a:p>
            <a:pPr marL="0" marR="0" algn="just">
              <a:lnSpc>
                <a:spcPct val="200000"/>
              </a:lnSpc>
              <a:spcBef>
                <a:spcPts val="1440"/>
              </a:spcBef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. S2 A comparison of meta-model performance on different combinations of the 7 best base classifiers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X axis shows the combination of base classifiers being evaluated while the y axis shows the best accuracy of the 6 meta-learning models.</a:t>
            </a:r>
          </a:p>
          <a:p>
            <a:pPr marL="0" marR="0" algn="just">
              <a:lnSpc>
                <a:spcPct val="200000"/>
              </a:lnSpc>
              <a:spcBef>
                <a:spcPts val="1440"/>
              </a:spcBef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. S3 An evaluation of the effect of different numbers of base classifiers on meta-model performance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X axis shows which model or classifier is being shown while the Y axis shows the score and respective metric being evaluated. Each subfigure shows a different evaluation metric (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, B, C, D, E, F, G, H, 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).</a:t>
            </a:r>
          </a:p>
          <a:p>
            <a:pPr marL="0" marR="0" algn="just">
              <a:lnSpc>
                <a:spcPct val="200000"/>
              </a:lnSpc>
              <a:spcBef>
                <a:spcPts val="1440"/>
              </a:spcBef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Table 1 The different classifiers tested in each block with the parameters used for each.  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03574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D9F6DF6-BF8A-83C6-C7B0-4CCCEF91D7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2952" y="402681"/>
            <a:ext cx="7315200" cy="54864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4310CB1-725B-D66E-5C57-BC3D6D98F4C0}"/>
              </a:ext>
            </a:extLst>
          </p:cNvPr>
          <p:cNvSpPr txBox="1"/>
          <p:nvPr/>
        </p:nvSpPr>
        <p:spPr>
          <a:xfrm>
            <a:off x="3198052" y="5889081"/>
            <a:ext cx="6100996" cy="22238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1440"/>
              </a:spcBef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. S1 An evaluation different numbers of base classifiers on meta-model performance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X axis shows which model or classifier is being shown while the Y axis shows the score and respective metric being evaluated.</a:t>
            </a:r>
          </a:p>
        </p:txBody>
      </p:sp>
    </p:spTree>
    <p:extLst>
      <p:ext uri="{BB962C8B-B14F-4D97-AF65-F5344CB8AC3E}">
        <p14:creationId xmlns:p14="http://schemas.microsoft.com/office/powerpoint/2010/main" val="32883566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0838869-1AF7-4294-8F02-0AE14C97A60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38235"/>
          <a:stretch/>
        </p:blipFill>
        <p:spPr>
          <a:xfrm>
            <a:off x="3128288" y="0"/>
            <a:ext cx="5935424" cy="576584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2D3CB25-49B1-0391-C032-850B3BCBE0A7}"/>
              </a:ext>
            </a:extLst>
          </p:cNvPr>
          <p:cNvSpPr txBox="1"/>
          <p:nvPr/>
        </p:nvSpPr>
        <p:spPr>
          <a:xfrm>
            <a:off x="1522751" y="5654091"/>
            <a:ext cx="9146498" cy="22238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1440"/>
              </a:spcBef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. S2 A comparison of meta-model performance on different combinations of the 7 best base classifiers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X axis shows the combination of base classifiers being evaluated while the y axis shows the best accuracy of the 6 meta-learning models.</a:t>
            </a:r>
          </a:p>
        </p:txBody>
      </p:sp>
    </p:spTree>
    <p:extLst>
      <p:ext uri="{BB962C8B-B14F-4D97-AF65-F5344CB8AC3E}">
        <p14:creationId xmlns:p14="http://schemas.microsoft.com/office/powerpoint/2010/main" val="6399939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B2AA098-98F2-4FA8-9550-9665AA45E5A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1F5EEDB-E83C-49DC-F2E1-BF14E3F209E5}"/>
              </a:ext>
            </a:extLst>
          </p:cNvPr>
          <p:cNvGrpSpPr/>
          <p:nvPr/>
        </p:nvGrpSpPr>
        <p:grpSpPr>
          <a:xfrm>
            <a:off x="1844386" y="0"/>
            <a:ext cx="9155588" cy="6906126"/>
            <a:chOff x="301925" y="0"/>
            <a:chExt cx="11572800" cy="868680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010508DF-0B70-3A8E-7CFC-6558BE9E6FF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1925" y="0"/>
              <a:ext cx="3857600" cy="28932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7A5A35AE-4817-8B31-A77A-E68B4592535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59525" y="0"/>
              <a:ext cx="3857600" cy="28932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7B15CF8-71F1-0EF4-F66D-414BB8837F5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017125" y="0"/>
              <a:ext cx="3857600" cy="289320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47873CA7-7960-420B-E92B-F0485EAAF1D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159525" y="5786400"/>
              <a:ext cx="3857600" cy="289320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C4E544BC-CB63-F9E0-044C-70F06BACF98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017125" y="5786400"/>
              <a:ext cx="3857600" cy="289320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C7AB59EB-E471-9434-EDCE-66EBC4ECDA9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01925" y="2900400"/>
              <a:ext cx="3857600" cy="2893200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3CE074FF-1715-C7C2-D20B-32754104BD4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8017125" y="2893200"/>
              <a:ext cx="3857600" cy="2893200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FB1B0539-0D0C-AA14-B26D-B944E011F0F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159525" y="2900400"/>
              <a:ext cx="3857600" cy="2893200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D11AD7AE-C412-ED2E-397B-3E7855DF20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01925" y="5793600"/>
              <a:ext cx="3857600" cy="2893200"/>
            </a:xfrm>
            <a:prstGeom prst="rect">
              <a:avLst/>
            </a:prstGeom>
          </p:spPr>
        </p:pic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78880657-F998-03E3-2AB3-185FD489ACAC}"/>
              </a:ext>
            </a:extLst>
          </p:cNvPr>
          <p:cNvSpPr txBox="1"/>
          <p:nvPr/>
        </p:nvSpPr>
        <p:spPr>
          <a:xfrm>
            <a:off x="1029298" y="6894678"/>
            <a:ext cx="10785763" cy="16699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1440"/>
              </a:spcBef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. S3 An evaluation of the effect of different numbers of base classifiers on meta-model performance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X axis shows which model or classifier is being shown while the Y axis shows the score and respective metric being evaluated. Each subfigure shows a different evaluation metric (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, B, C, D, E, F, G, H, 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).</a:t>
            </a:r>
          </a:p>
        </p:txBody>
      </p:sp>
    </p:spTree>
    <p:extLst>
      <p:ext uri="{BB962C8B-B14F-4D97-AF65-F5344CB8AC3E}">
        <p14:creationId xmlns:p14="http://schemas.microsoft.com/office/powerpoint/2010/main" val="28072362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A3D46AB-D74A-E74B-7DFE-2A6EAC8EF1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5324258"/>
              </p:ext>
            </p:extLst>
          </p:nvPr>
        </p:nvGraphicFramePr>
        <p:xfrm>
          <a:off x="3324200" y="897142"/>
          <a:ext cx="5543599" cy="5508695"/>
        </p:xfrm>
        <a:graphic>
          <a:graphicData uri="http://schemas.openxmlformats.org/drawingml/2006/table">
            <a:tbl>
              <a:tblPr firstRow="1" firstCol="1" bandRow="1"/>
              <a:tblGrid>
                <a:gridCol w="1651827">
                  <a:extLst>
                    <a:ext uri="{9D8B030D-6E8A-4147-A177-3AD203B41FA5}">
                      <a16:colId xmlns:a16="http://schemas.microsoft.com/office/drawing/2014/main" val="3952015769"/>
                    </a:ext>
                  </a:extLst>
                </a:gridCol>
                <a:gridCol w="1313643">
                  <a:extLst>
                    <a:ext uri="{9D8B030D-6E8A-4147-A177-3AD203B41FA5}">
                      <a16:colId xmlns:a16="http://schemas.microsoft.com/office/drawing/2014/main" val="614001921"/>
                    </a:ext>
                  </a:extLst>
                </a:gridCol>
                <a:gridCol w="1264486">
                  <a:extLst>
                    <a:ext uri="{9D8B030D-6E8A-4147-A177-3AD203B41FA5}">
                      <a16:colId xmlns:a16="http://schemas.microsoft.com/office/drawing/2014/main" val="448503288"/>
                    </a:ext>
                  </a:extLst>
                </a:gridCol>
                <a:gridCol w="1313643">
                  <a:extLst>
                    <a:ext uri="{9D8B030D-6E8A-4147-A177-3AD203B41FA5}">
                      <a16:colId xmlns:a16="http://schemas.microsoft.com/office/drawing/2014/main" val="3287151757"/>
                    </a:ext>
                  </a:extLst>
                </a:gridCol>
              </a:tblGrid>
              <a:tr h="39095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24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lock A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en-US" sz="11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24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lock B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en-US" sz="11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7956583"/>
                  </a:ext>
                </a:extLst>
              </a:tr>
              <a:tr h="17767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lassifier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Parameters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lassifier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Parameters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3070769"/>
                  </a:ext>
                </a:extLst>
              </a:tr>
              <a:tr h="17497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LP (Multi-layer Perceptron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ctivation: "relu"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lpha: 0.0001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learning_rate: "constant"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ax_iter: 210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atch_size: 8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olver: "adam"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hidden_layer_sizes: (100, 100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LP (Multi-layer Perceptron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ctivation: "relu"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lpha: 0.0001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learning_rate: "constant"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ax_iter: 210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atch_size: 8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olver: "adam"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hidden_layer_sizes: (100, 100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1878207"/>
                  </a:ext>
                </a:extLst>
              </a:tr>
              <a:tr h="37662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LR (Logistic Regression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ax_iter: 700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LR (Logistic Regression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efault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3938745"/>
                  </a:ext>
                </a:extLst>
              </a:tr>
              <a:tr h="18046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NB (Naïve Bayes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efault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NB (Naïve Bayes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efault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5978208"/>
                  </a:ext>
                </a:extLst>
              </a:tr>
              <a:tr h="37662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RF (Random Forest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efault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RF (Random Forest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efault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4360374"/>
                  </a:ext>
                </a:extLst>
              </a:tr>
              <a:tr h="18046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VM (Linear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efault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VM (Linear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efault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03724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VM (RBF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efault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VM (RBF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efault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7138773"/>
                  </a:ext>
                </a:extLst>
              </a:tr>
              <a:tr h="965096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XGB (</a:t>
                      </a:r>
                      <a:r>
                        <a:rPr lang="en-US" sz="110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XGBoost</a:t>
                      </a:r>
                      <a:r>
                        <a:rPr lang="en-US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)</a:t>
                      </a:r>
                      <a:endParaRPr lang="en-US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n_estimators: 300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use_label_encoder: False</a:t>
                      </a:r>
                      <a:b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eval_metric: 'logloss'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T (Decision Tree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efault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7299391"/>
                  </a:ext>
                </a:extLst>
              </a:tr>
              <a:tr h="37662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QDA (Quadratic Discriminant Analysis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efault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en-US" sz="11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en-US" sz="11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6882227"/>
                  </a:ext>
                </a:extLst>
              </a:tr>
              <a:tr h="37662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KNN (K Nearest Neighbors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efault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en-US" sz="11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en-US" sz="11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4405258"/>
                  </a:ext>
                </a:extLst>
              </a:tr>
              <a:tr h="18046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T (Decision Tree)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efault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buNone/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</a:p>
                  </a:txBody>
                  <a:tcPr marL="63965" marR="639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206628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F9B9D97-A010-479C-23B5-C39A65B8C06B}"/>
              </a:ext>
            </a:extLst>
          </p:cNvPr>
          <p:cNvSpPr txBox="1"/>
          <p:nvPr/>
        </p:nvSpPr>
        <p:spPr>
          <a:xfrm>
            <a:off x="3046770" y="6926834"/>
            <a:ext cx="6098458" cy="11159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1440"/>
              </a:spcBef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Table 1 The different classifiers tested in each block with the parameters used for each.  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0474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84a28940-b464-41c3-ba3b-b4fa6665bc05}" enabled="0" method="" siteId="{84a28940-b464-41c3-ba3b-b4fa6665bc05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777</TotalTime>
  <Words>566</Words>
  <Application>Microsoft Macintosh PowerPoint</Application>
  <PresentationFormat>Custom</PresentationFormat>
  <Paragraphs>5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Office Theme</vt:lpstr>
      <vt:lpstr>SUPPLEMENTAL FIGURE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eterson, nick b</dc:creator>
  <cp:lastModifiedBy>peterson, nick b</cp:lastModifiedBy>
  <cp:revision>39</cp:revision>
  <dcterms:created xsi:type="dcterms:W3CDTF">2025-03-10T16:16:55Z</dcterms:created>
  <dcterms:modified xsi:type="dcterms:W3CDTF">2025-12-30T19:58:03Z</dcterms:modified>
</cp:coreProperties>
</file>